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62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014" autoAdjust="0"/>
    <p:restoredTop sz="93447" autoAdjust="0"/>
  </p:normalViewPr>
  <p:slideViewPr>
    <p:cSldViewPr snapToGrid="0">
      <p:cViewPr varScale="1">
        <p:scale>
          <a:sx n="107" d="100"/>
          <a:sy n="107" d="100"/>
        </p:scale>
        <p:origin x="120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78891-3B70-4B94-BAEE-88FEB18586E5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54113"/>
            <a:ext cx="5540375" cy="31162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861"/>
            <a:ext cx="5608320" cy="363670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97DE3F-8F04-476B-AF8E-D0D1D2CF36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376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398A71-B923-7FE0-00B3-E79D085A8F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31CE5AD7-4441-0FD9-CE43-EE11A53C37B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515E0C0-4AAA-E66A-1207-9D088EE311B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AEA7F81-DA74-37AF-0897-FBE64B27CEE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97DE3F-8F04-476B-AF8E-D0D1D2CF36A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560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ECF64-62E6-4B8E-90D5-84029C0D69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FC55DB-270A-FE06-C0C2-8C3B7960E0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6E5E1-EFE0-D916-EE58-848BFE98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624415-F5A9-5098-5E2E-9C0587248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5B319-3B47-4B86-1939-2395AC0E0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07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A48B98-5F78-5FAE-F487-932D8CDB5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050F19-B690-1C98-4C97-C2EB70165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7D955-E84D-DA92-71E0-19983DE7E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E7442-0FA0-0662-4880-EB70B5A38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60A8C-DACC-C25D-EA31-228637473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473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FAA582-80EA-8FFE-6717-8F7660FD22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06AB09-1D1B-598A-3196-87DE1F9B8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1D5950-191C-D2E6-3974-A35C46151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24EE5-9452-84DF-1A7F-3D2E1C52C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FCC4B-8E7D-2B5D-0791-B950B7622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699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103AE-2CA8-D316-AFE5-E63ABEA098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C24A61-629B-67A4-921D-8E595D3372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DC599-085D-F352-6523-1CE8CB325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56BCE-8FDD-DC7C-BFA2-646FCFD7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E68B1-7026-6D9A-AA6F-86D5A2244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700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159DE-46C7-7112-D8F4-AC0846F4D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51615-850B-8EE3-CD07-A41BCC96B0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D6D35-6EEE-76CB-A7B3-9393C6285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1BD30-B32D-92E3-8943-51DD5C005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03268-9725-9EEB-4396-3DC7FE27B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064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EA0BF-849F-9564-DDCD-9D6E2F52E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B608DA-F013-88F9-DECC-12F3D99742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B9CD44-76E8-EB8B-4F78-D717428AF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3A4DA9-3BC5-6799-6BA0-C4C199171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50E6D9-1A18-C6B4-92F5-CFF5A6A40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A9BB7A-3135-2BF6-6401-D24789835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2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FAC7F-C16F-D8C4-3D2E-AD085291B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FF2890-2C17-37FD-0A84-F3892166D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05EA2C-667E-3AB7-E26B-8A78C667B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F41096-C25D-2831-01D7-2D3B934545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951FEE-E9E0-6A8E-CE16-01F17AD753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5F7DA7-B82C-D8DB-4CB6-A2EBB76DA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914E22-4792-AF32-96EE-BA1F85350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12D419-4CC5-FE70-6BE4-A530667D1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6F74C-1488-E29C-0EF7-29815B736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1B1ADC-5E07-A38D-9B4D-54BDEEA37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D3A60B-1623-0F7E-17FA-23C909281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3969C3-F1A5-90A5-D54E-E6258A2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12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1E7637-6E7A-283C-6283-60359DF8E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E4978E-B117-9941-29EC-A70E0FA98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FD7E27-B98F-6776-573A-EBACEC9A4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9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DCCCB-1A48-3A52-BAE1-BFED42D54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934DA0-DFB0-DE2B-9DD5-A6E08348AD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25438A-98D3-6F12-5556-FD99DD448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FD4AED-5D58-CA1B-FD3F-15506906C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CB4F1-064F-7EE5-ECD7-3AF181820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6C0817-EA96-463A-7FC5-0238C772B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498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5C869-05BF-9F9A-18D3-0662AB90A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CA6735-F013-975D-91C3-36205A9383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43637-448B-0412-ED75-BFAC61BA7F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EF5FAF-7C11-BCAF-C5F7-9DB8DF122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37007-F46F-052B-F5EC-2C05A50B9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C9CED-02A8-286D-37DD-8F866DB23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83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47AEBF-16CF-0A62-F011-6A11A4E99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01EB9A-1BFA-5855-3D70-BBE95E170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12A36-4D3F-6E80-E41F-79314E9200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49328-9A8E-A056-517B-F9FD5B9D88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0532B-B214-6D1B-94CE-81305ED7AB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233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49690F-2D69-3A74-5386-535FA62E08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with red dots and white text&#10;&#10;Description automatically generated">
            <a:extLst>
              <a:ext uri="{FF2B5EF4-FFF2-40B4-BE49-F238E27FC236}">
                <a16:creationId xmlns:a16="http://schemas.microsoft.com/office/drawing/2014/main" id="{4C6CC6F7-31CB-4DEC-3F01-D819A3BBD58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4"/>
          <a:stretch/>
        </p:blipFill>
        <p:spPr>
          <a:xfrm>
            <a:off x="420211" y="1824832"/>
            <a:ext cx="5380429" cy="3825718"/>
          </a:xfrm>
          <a:prstGeom prst="rect">
            <a:avLst/>
          </a:prstGeom>
        </p:spPr>
      </p:pic>
      <p:pic>
        <p:nvPicPr>
          <p:cNvPr id="8" name="Picture 7" descr="A graph with red dots and lines&#10;&#10;Description automatically generated">
            <a:extLst>
              <a:ext uri="{FF2B5EF4-FFF2-40B4-BE49-F238E27FC236}">
                <a16:creationId xmlns:a16="http://schemas.microsoft.com/office/drawing/2014/main" id="{942781F0-5297-0193-402E-04C63B98E7A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48"/>
          <a:stretch/>
        </p:blipFill>
        <p:spPr>
          <a:xfrm>
            <a:off x="6096000" y="1723573"/>
            <a:ext cx="5335626" cy="402823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5431D7B-9035-AED2-DDF5-2D6D8AD61D5E}"/>
              </a:ext>
            </a:extLst>
          </p:cNvPr>
          <p:cNvSpPr txBox="1"/>
          <p:nvPr/>
        </p:nvSpPr>
        <p:spPr>
          <a:xfrm>
            <a:off x="87085" y="1084405"/>
            <a:ext cx="751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302BA8-557E-0101-5C48-E52C5CE82AD9}"/>
              </a:ext>
            </a:extLst>
          </p:cNvPr>
          <p:cNvSpPr txBox="1"/>
          <p:nvPr/>
        </p:nvSpPr>
        <p:spPr>
          <a:xfrm>
            <a:off x="5797724" y="1084405"/>
            <a:ext cx="1018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2D39DE-D0C9-726B-77FA-6A4BDE17B11F}"/>
              </a:ext>
            </a:extLst>
          </p:cNvPr>
          <p:cNvSpPr txBox="1"/>
          <p:nvPr/>
        </p:nvSpPr>
        <p:spPr>
          <a:xfrm>
            <a:off x="3767365" y="1370973"/>
            <a:ext cx="2416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aselin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314ECC7-5ECF-7F1B-707A-1FBBD3C477A7}"/>
              </a:ext>
            </a:extLst>
          </p:cNvPr>
          <p:cNvSpPr txBox="1"/>
          <p:nvPr/>
        </p:nvSpPr>
        <p:spPr>
          <a:xfrm>
            <a:off x="9359344" y="1370973"/>
            <a:ext cx="2416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Week 1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E43722-EC52-136B-6C4C-7C42DB6AEC0C}"/>
              </a:ext>
            </a:extLst>
          </p:cNvPr>
          <p:cNvSpPr txBox="1"/>
          <p:nvPr/>
        </p:nvSpPr>
        <p:spPr>
          <a:xfrm>
            <a:off x="304800" y="6302188"/>
            <a:ext cx="11627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8. Summary of biological processes associated with PFS in baseline and W12 cfDNA plasma based on mutational profiles</a:t>
            </a:r>
            <a:r>
              <a:rPr lang="en-US" sz="9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900" kern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-B) </a:t>
            </a:r>
            <a:r>
              <a:rPr lang="en-US" sz="9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orest plots summarize HR of mutations in genes among biological processes significantly associated with PFS among (A) baseline and (B) W12 samples.</a:t>
            </a: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968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47</TotalTime>
  <Words>58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Quann, Karen</cp:lastModifiedBy>
  <cp:revision>308</cp:revision>
  <cp:lastPrinted>2023-08-16T18:12:39Z</cp:lastPrinted>
  <dcterms:created xsi:type="dcterms:W3CDTF">2023-05-04T15:52:47Z</dcterms:created>
  <dcterms:modified xsi:type="dcterms:W3CDTF">2025-10-21T17:28:04Z</dcterms:modified>
</cp:coreProperties>
</file>